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7" r:id="rId2"/>
    <p:sldId id="262" r:id="rId3"/>
    <p:sldId id="258" r:id="rId4"/>
    <p:sldId id="259" r:id="rId5"/>
    <p:sldId id="260" r:id="rId6"/>
    <p:sldId id="268" r:id="rId7"/>
    <p:sldId id="269" r:id="rId8"/>
    <p:sldId id="270" r:id="rId9"/>
    <p:sldId id="266" r:id="rId10"/>
    <p:sldId id="267" r:id="rId11"/>
    <p:sldId id="271" r:id="rId12"/>
    <p:sldId id="273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4F36AB-BB68-41FB-B3E0-6FCBD3EC8A04}" type="datetimeFigureOut">
              <a:rPr lang="en-US" smtClean="0"/>
              <a:t>12/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193906-7C60-4E4C-AB84-7BAEF04EC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0199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ACD31D-390F-4833-BF5E-571E2775D0E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9756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540B2-E488-4B4A-9EB0-F19F522CC2F7}" type="datetimeFigureOut">
              <a:rPr lang="en-US" smtClean="0"/>
              <a:t>1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0E4C-97CA-4E19-B7E4-BD7DA0053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810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540B2-E488-4B4A-9EB0-F19F522CC2F7}" type="datetimeFigureOut">
              <a:rPr lang="en-US" smtClean="0"/>
              <a:t>1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0E4C-97CA-4E19-B7E4-BD7DA0053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5531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540B2-E488-4B4A-9EB0-F19F522CC2F7}" type="datetimeFigureOut">
              <a:rPr lang="en-US" smtClean="0"/>
              <a:t>1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0E4C-97CA-4E19-B7E4-BD7DA0053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8714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540B2-E488-4B4A-9EB0-F19F522CC2F7}" type="datetimeFigureOut">
              <a:rPr lang="en-US" smtClean="0"/>
              <a:t>1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0E4C-97CA-4E19-B7E4-BD7DA0053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97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540B2-E488-4B4A-9EB0-F19F522CC2F7}" type="datetimeFigureOut">
              <a:rPr lang="en-US" smtClean="0"/>
              <a:t>1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0E4C-97CA-4E19-B7E4-BD7DA0053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370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540B2-E488-4B4A-9EB0-F19F522CC2F7}" type="datetimeFigureOut">
              <a:rPr lang="en-US" smtClean="0"/>
              <a:t>12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0E4C-97CA-4E19-B7E4-BD7DA0053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2324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540B2-E488-4B4A-9EB0-F19F522CC2F7}" type="datetimeFigureOut">
              <a:rPr lang="en-US" smtClean="0"/>
              <a:t>12/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0E4C-97CA-4E19-B7E4-BD7DA0053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60362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540B2-E488-4B4A-9EB0-F19F522CC2F7}" type="datetimeFigureOut">
              <a:rPr lang="en-US" smtClean="0"/>
              <a:t>12/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0E4C-97CA-4E19-B7E4-BD7DA0053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9869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540B2-E488-4B4A-9EB0-F19F522CC2F7}" type="datetimeFigureOut">
              <a:rPr lang="en-US" smtClean="0"/>
              <a:t>12/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0E4C-97CA-4E19-B7E4-BD7DA0053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953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540B2-E488-4B4A-9EB0-F19F522CC2F7}" type="datetimeFigureOut">
              <a:rPr lang="en-US" smtClean="0"/>
              <a:t>12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0E4C-97CA-4E19-B7E4-BD7DA0053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7821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540B2-E488-4B4A-9EB0-F19F522CC2F7}" type="datetimeFigureOut">
              <a:rPr lang="en-US" smtClean="0"/>
              <a:t>12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5A0E4C-97CA-4E19-B7E4-BD7DA0053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575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1540B2-E488-4B4A-9EB0-F19F522CC2F7}" type="datetimeFigureOut">
              <a:rPr lang="en-US" smtClean="0"/>
              <a:t>1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A0E4C-97CA-4E19-B7E4-BD7DA0053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968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7.png"/><Relationship Id="rId4" Type="http://schemas.microsoft.com/office/2007/relationships/hdphoto" Target="../media/hdphoto1.wdp"/><Relationship Id="rId9" Type="http://schemas.openxmlformats.org/officeDocument/2006/relationships/image" Target="../media/image6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tiff"/><Relationship Id="rId2" Type="http://schemas.openxmlformats.org/officeDocument/2006/relationships/image" Target="../media/image39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png"/><Relationship Id="rId4" Type="http://schemas.openxmlformats.org/officeDocument/2006/relationships/image" Target="../media/image41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7" Type="http://schemas.openxmlformats.org/officeDocument/2006/relationships/image" Target="../media/image26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2.wdp"/><Relationship Id="rId5" Type="http://schemas.openxmlformats.org/officeDocument/2006/relationships/image" Target="../media/image44.png"/><Relationship Id="rId4" Type="http://schemas.microsoft.com/office/2007/relationships/hdphoto" Target="../media/hdphoto21.wdp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microsoft.com/office/2007/relationships/hdphoto" Target="../media/hdphoto23.wdp"/><Relationship Id="rId7" Type="http://schemas.openxmlformats.org/officeDocument/2006/relationships/image" Target="../media/image48.tiff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4.wdp"/><Relationship Id="rId5" Type="http://schemas.openxmlformats.org/officeDocument/2006/relationships/image" Target="../media/image47.png"/><Relationship Id="rId4" Type="http://schemas.openxmlformats.org/officeDocument/2006/relationships/image" Target="../media/image46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4.wdp"/><Relationship Id="rId5" Type="http://schemas.openxmlformats.org/officeDocument/2006/relationships/image" Target="../media/image9.png"/><Relationship Id="rId4" Type="http://schemas.microsoft.com/office/2007/relationships/hdphoto" Target="../media/hdphoto3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7.png"/><Relationship Id="rId4" Type="http://schemas.openxmlformats.org/officeDocument/2006/relationships/image" Target="../media/image13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microsoft.com/office/2007/relationships/hdphoto" Target="../media/hdphoto5.wdp"/><Relationship Id="rId7" Type="http://schemas.openxmlformats.org/officeDocument/2006/relationships/image" Target="../media/image18.tiff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microsoft.com/office/2007/relationships/hdphoto" Target="../media/hdphoto6.wdp"/><Relationship Id="rId5" Type="http://schemas.openxmlformats.org/officeDocument/2006/relationships/image" Target="../media/image17.png"/><Relationship Id="rId4" Type="http://schemas.openxmlformats.org/officeDocument/2006/relationships/image" Target="../media/image16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tiff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microsoft.com/office/2007/relationships/hdphoto" Target="../media/hdphoto7.wdp"/><Relationship Id="rId7" Type="http://schemas.microsoft.com/office/2007/relationships/hdphoto" Target="../media/hdphoto8.wdp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5" Type="http://schemas.openxmlformats.org/officeDocument/2006/relationships/image" Target="../media/image24.tiff"/><Relationship Id="rId4" Type="http://schemas.openxmlformats.org/officeDocument/2006/relationships/image" Target="../media/image2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microsoft.com/office/2007/relationships/hdphoto" Target="../media/hdphoto9.wdp"/><Relationship Id="rId7" Type="http://schemas.microsoft.com/office/2007/relationships/hdphoto" Target="../media/hdphoto11.wdp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microsoft.com/office/2007/relationships/hdphoto" Target="../media/hdphoto10.wdp"/><Relationship Id="rId10" Type="http://schemas.openxmlformats.org/officeDocument/2006/relationships/image" Target="../media/image26.png"/><Relationship Id="rId4" Type="http://schemas.openxmlformats.org/officeDocument/2006/relationships/image" Target="../media/image28.png"/><Relationship Id="rId9" Type="http://schemas.microsoft.com/office/2007/relationships/hdphoto" Target="../media/hdphoto12.wdp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microsoft.com/office/2007/relationships/hdphoto" Target="../media/hdphoto13.wdp"/><Relationship Id="rId7" Type="http://schemas.microsoft.com/office/2007/relationships/hdphoto" Target="../media/hdphoto15.wdp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5" Type="http://schemas.microsoft.com/office/2007/relationships/hdphoto" Target="../media/hdphoto14.wdp"/><Relationship Id="rId10" Type="http://schemas.openxmlformats.org/officeDocument/2006/relationships/image" Target="../media/image26.png"/><Relationship Id="rId4" Type="http://schemas.openxmlformats.org/officeDocument/2006/relationships/image" Target="../media/image32.png"/><Relationship Id="rId9" Type="http://schemas.microsoft.com/office/2007/relationships/hdphoto" Target="../media/hdphoto16.wdp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3" Type="http://schemas.microsoft.com/office/2007/relationships/hdphoto" Target="../media/hdphoto17.wdp"/><Relationship Id="rId7" Type="http://schemas.microsoft.com/office/2007/relationships/hdphoto" Target="../media/hdphoto19.wdp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5" Type="http://schemas.microsoft.com/office/2007/relationships/hdphoto" Target="../media/hdphoto18.wdp"/><Relationship Id="rId10" Type="http://schemas.openxmlformats.org/officeDocument/2006/relationships/image" Target="../media/image26.png"/><Relationship Id="rId4" Type="http://schemas.openxmlformats.org/officeDocument/2006/relationships/image" Target="../media/image36.png"/><Relationship Id="rId9" Type="http://schemas.microsoft.com/office/2007/relationships/hdphoto" Target="../media/hdphoto20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65106" y="146367"/>
            <a:ext cx="4852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ul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edited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mmunoblot imag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or Figure 1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Group 23"/>
          <p:cNvGrpSpPr/>
          <p:nvPr/>
        </p:nvGrpSpPr>
        <p:grpSpPr>
          <a:xfrm>
            <a:off x="-127736" y="835632"/>
            <a:ext cx="6636927" cy="5106754"/>
            <a:chOff x="-6504568" y="428636"/>
            <a:chExt cx="6636927" cy="5106754"/>
          </a:xfrm>
        </p:grpSpPr>
        <p:grpSp>
          <p:nvGrpSpPr>
            <p:cNvPr id="26" name="Group 25"/>
            <p:cNvGrpSpPr/>
            <p:nvPr/>
          </p:nvGrpSpPr>
          <p:grpSpPr>
            <a:xfrm>
              <a:off x="-6504568" y="2946729"/>
              <a:ext cx="3396275" cy="1117571"/>
              <a:chOff x="6119647" y="3738818"/>
              <a:chExt cx="3396275" cy="1117571"/>
            </a:xfrm>
          </p:grpSpPr>
          <p:grpSp>
            <p:nvGrpSpPr>
              <p:cNvPr id="51" name="Group 50"/>
              <p:cNvGrpSpPr/>
              <p:nvPr/>
            </p:nvGrpSpPr>
            <p:grpSpPr>
              <a:xfrm>
                <a:off x="7135014" y="3877318"/>
                <a:ext cx="2380908" cy="979071"/>
                <a:chOff x="7177932" y="4263089"/>
                <a:chExt cx="2525432" cy="979071"/>
              </a:xfrm>
            </p:grpSpPr>
            <p:pic>
              <p:nvPicPr>
                <p:cNvPr id="53" name="Picture 52" descr="2.png"/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8732" t="39158" r="833" b="12354"/>
                <a:stretch/>
              </p:blipFill>
              <p:spPr>
                <a:xfrm>
                  <a:off x="8312174" y="4271748"/>
                  <a:ext cx="1391190" cy="970412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54" name="Picture 53" descr="4.png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bright="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5093" b="1"/>
                <a:stretch/>
              </p:blipFill>
              <p:spPr>
                <a:xfrm>
                  <a:off x="7177932" y="4263089"/>
                  <a:ext cx="1296144" cy="970412"/>
                </a:xfrm>
                <a:prstGeom prst="rect">
                  <a:avLst/>
                </a:prstGeom>
              </p:spPr>
            </p:pic>
          </p:grpSp>
          <p:sp>
            <p:nvSpPr>
              <p:cNvPr id="52" name="TextBox 51"/>
              <p:cNvSpPr txBox="1"/>
              <p:nvPr/>
            </p:nvSpPr>
            <p:spPr>
              <a:xfrm>
                <a:off x="6119647" y="3738818"/>
                <a:ext cx="91185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l-GR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7" name="TextBox 26"/>
            <p:cNvSpPr txBox="1"/>
            <p:nvPr/>
          </p:nvSpPr>
          <p:spPr>
            <a:xfrm>
              <a:off x="-4419872" y="1331640"/>
              <a:ext cx="11694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CREB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8" name="Picture 3" descr="C:\Users\FBM402\Desktop\그림3.png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16" t="1435" r="1809" b="5545"/>
            <a:stretch/>
          </p:blipFill>
          <p:spPr bwMode="auto">
            <a:xfrm>
              <a:off x="-5832143" y="4576738"/>
              <a:ext cx="2469879" cy="9586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" name="Picture 28" descr="Untitled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10"/>
            <a:stretch/>
          </p:blipFill>
          <p:spPr>
            <a:xfrm>
              <a:off x="-2265512" y="755576"/>
              <a:ext cx="2397871" cy="2245020"/>
            </a:xfrm>
            <a:prstGeom prst="rect">
              <a:avLst/>
            </a:prstGeom>
            <a:ln>
              <a:noFill/>
            </a:ln>
          </p:spPr>
        </p:pic>
        <p:sp>
          <p:nvSpPr>
            <p:cNvPr id="30" name="TextBox 29"/>
            <p:cNvSpPr txBox="1"/>
            <p:nvPr/>
          </p:nvSpPr>
          <p:spPr>
            <a:xfrm>
              <a:off x="-2515196" y="428636"/>
              <a:ext cx="11694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EB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1" name="Picture 2" descr="C:\Users\FBM402\Desktop\Chemidoc Touch Images 2017-01-26_13.15.46\2017-01-26 11hr 38min 10sec.tif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18000" contrast="3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071" t="8811" r="15733" b="45187"/>
            <a:stretch/>
          </p:blipFill>
          <p:spPr bwMode="auto">
            <a:xfrm flipH="1" flipV="1">
              <a:off x="-5427984" y="755576"/>
              <a:ext cx="2376264" cy="11780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2" name="Picture 31" descr="Untitled.png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5621481" y="1848925"/>
              <a:ext cx="2739634" cy="1194791"/>
            </a:xfrm>
            <a:prstGeom prst="rect">
              <a:avLst/>
            </a:prstGeom>
          </p:spPr>
        </p:pic>
        <p:sp>
          <p:nvSpPr>
            <p:cNvPr id="33" name="TextBox 32"/>
            <p:cNvSpPr txBox="1"/>
            <p:nvPr/>
          </p:nvSpPr>
          <p:spPr>
            <a:xfrm>
              <a:off x="-6125255" y="432410"/>
              <a:ext cx="11694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CREB</a:t>
              </a:r>
              <a:endPara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-6125796" y="1828853"/>
              <a:ext cx="11694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CREB</a:t>
              </a:r>
              <a:endPara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5" name="Rectangle 54"/>
          <p:cNvSpPr/>
          <p:nvPr/>
        </p:nvSpPr>
        <p:spPr>
          <a:xfrm>
            <a:off x="2200550" y="1537971"/>
            <a:ext cx="1026010" cy="2931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Rectangle 75"/>
          <p:cNvSpPr/>
          <p:nvPr/>
        </p:nvSpPr>
        <p:spPr>
          <a:xfrm>
            <a:off x="1935633" y="5557611"/>
            <a:ext cx="1078935" cy="2931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ectangle 76"/>
          <p:cNvSpPr/>
          <p:nvPr/>
        </p:nvSpPr>
        <p:spPr>
          <a:xfrm>
            <a:off x="4391998" y="1796462"/>
            <a:ext cx="1026010" cy="2931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48848" y="878587"/>
            <a:ext cx="1323710" cy="408459"/>
          </a:xfrm>
          <a:prstGeom prst="rect">
            <a:avLst/>
          </a:prstGeom>
        </p:spPr>
      </p:pic>
      <p:pic>
        <p:nvPicPr>
          <p:cNvPr id="82" name="Picture 81"/>
          <p:cNvPicPr>
            <a:picLocks noChangeAspect="1"/>
          </p:cNvPicPr>
          <p:nvPr/>
        </p:nvPicPr>
        <p:blipFill rotWithShape="1">
          <a:blip r:embed="rId10"/>
          <a:srcRect l="27009" b="644"/>
          <a:stretch/>
        </p:blipFill>
        <p:spPr>
          <a:xfrm>
            <a:off x="2235366" y="882161"/>
            <a:ext cx="966187" cy="405824"/>
          </a:xfrm>
          <a:prstGeom prst="rect">
            <a:avLst/>
          </a:prstGeom>
        </p:spPr>
      </p:pic>
      <p:pic>
        <p:nvPicPr>
          <p:cNvPr id="83" name="Picture 8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50753" y="1401535"/>
            <a:ext cx="1323710" cy="408459"/>
          </a:xfrm>
          <a:prstGeom prst="rect">
            <a:avLst/>
          </a:prstGeom>
        </p:spPr>
      </p:pic>
      <p:pic>
        <p:nvPicPr>
          <p:cNvPr id="84" name="Picture 83"/>
          <p:cNvPicPr>
            <a:picLocks noChangeAspect="1"/>
          </p:cNvPicPr>
          <p:nvPr/>
        </p:nvPicPr>
        <p:blipFill rotWithShape="1">
          <a:blip r:embed="rId10"/>
          <a:srcRect l="27009" b="644"/>
          <a:stretch/>
        </p:blipFill>
        <p:spPr>
          <a:xfrm>
            <a:off x="5470270" y="1405109"/>
            <a:ext cx="1008631" cy="423652"/>
          </a:xfrm>
          <a:prstGeom prst="rect">
            <a:avLst/>
          </a:prstGeom>
        </p:spPr>
      </p:pic>
      <p:pic>
        <p:nvPicPr>
          <p:cNvPr id="85" name="Picture 8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99945" y="2311126"/>
            <a:ext cx="1323710" cy="408459"/>
          </a:xfrm>
          <a:prstGeom prst="rect">
            <a:avLst/>
          </a:prstGeom>
        </p:spPr>
      </p:pic>
      <p:pic>
        <p:nvPicPr>
          <p:cNvPr id="86" name="Picture 85"/>
          <p:cNvPicPr>
            <a:picLocks noChangeAspect="1"/>
          </p:cNvPicPr>
          <p:nvPr/>
        </p:nvPicPr>
        <p:blipFill rotWithShape="1">
          <a:blip r:embed="rId10"/>
          <a:srcRect l="27009" b="644"/>
          <a:stretch/>
        </p:blipFill>
        <p:spPr>
          <a:xfrm>
            <a:off x="2531475" y="2340590"/>
            <a:ext cx="966187" cy="405824"/>
          </a:xfrm>
          <a:prstGeom prst="rect">
            <a:avLst/>
          </a:prstGeom>
        </p:spPr>
      </p:pic>
      <p:pic>
        <p:nvPicPr>
          <p:cNvPr id="87" name="Picture 86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033316" y="2606235"/>
            <a:ext cx="1041175" cy="321277"/>
          </a:xfrm>
          <a:prstGeom prst="rect">
            <a:avLst/>
          </a:prstGeom>
        </p:spPr>
      </p:pic>
      <p:pic>
        <p:nvPicPr>
          <p:cNvPr id="88" name="Picture 87"/>
          <p:cNvPicPr>
            <a:picLocks noChangeAspect="1"/>
          </p:cNvPicPr>
          <p:nvPr/>
        </p:nvPicPr>
        <p:blipFill rotWithShape="1">
          <a:blip r:embed="rId10"/>
          <a:srcRect l="27009" b="644"/>
          <a:stretch/>
        </p:blipFill>
        <p:spPr>
          <a:xfrm>
            <a:off x="5066364" y="2600887"/>
            <a:ext cx="777630" cy="326625"/>
          </a:xfrm>
          <a:prstGeom prst="rect">
            <a:avLst/>
          </a:prstGeom>
        </p:spPr>
      </p:pic>
      <p:pic>
        <p:nvPicPr>
          <p:cNvPr id="89" name="Picture 88"/>
          <p:cNvPicPr>
            <a:picLocks noChangeAspect="1"/>
          </p:cNvPicPr>
          <p:nvPr/>
        </p:nvPicPr>
        <p:blipFill rotWithShape="1">
          <a:blip r:embed="rId10"/>
          <a:srcRect l="27009" b="644"/>
          <a:stretch/>
        </p:blipFill>
        <p:spPr>
          <a:xfrm>
            <a:off x="5809871" y="2600887"/>
            <a:ext cx="777630" cy="326625"/>
          </a:xfrm>
          <a:prstGeom prst="rect">
            <a:avLst/>
          </a:prstGeom>
        </p:spPr>
      </p:pic>
      <p:pic>
        <p:nvPicPr>
          <p:cNvPr id="90" name="Picture 8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88599" y="3527107"/>
            <a:ext cx="1604329" cy="495050"/>
          </a:xfrm>
          <a:prstGeom prst="rect">
            <a:avLst/>
          </a:prstGeom>
        </p:spPr>
      </p:pic>
      <p:pic>
        <p:nvPicPr>
          <p:cNvPr id="91" name="Picture 90"/>
          <p:cNvPicPr>
            <a:picLocks noChangeAspect="1"/>
          </p:cNvPicPr>
          <p:nvPr/>
        </p:nvPicPr>
        <p:blipFill rotWithShape="1">
          <a:blip r:embed="rId10"/>
          <a:srcRect l="27009" b="644"/>
          <a:stretch/>
        </p:blipFill>
        <p:spPr>
          <a:xfrm>
            <a:off x="2091916" y="3517900"/>
            <a:ext cx="1200535" cy="504257"/>
          </a:xfrm>
          <a:prstGeom prst="rect">
            <a:avLst/>
          </a:prstGeom>
        </p:spPr>
      </p:pic>
      <p:pic>
        <p:nvPicPr>
          <p:cNvPr id="92" name="Picture 9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28192" y="5032863"/>
            <a:ext cx="1700574" cy="524748"/>
          </a:xfrm>
          <a:prstGeom prst="rect">
            <a:avLst/>
          </a:prstGeom>
        </p:spPr>
      </p:pic>
      <p:pic>
        <p:nvPicPr>
          <p:cNvPr id="93" name="Picture 92"/>
          <p:cNvPicPr>
            <a:picLocks noChangeAspect="1"/>
          </p:cNvPicPr>
          <p:nvPr/>
        </p:nvPicPr>
        <p:blipFill rotWithShape="1">
          <a:blip r:embed="rId10"/>
          <a:srcRect l="27009" b="644"/>
          <a:stretch/>
        </p:blipFill>
        <p:spPr>
          <a:xfrm>
            <a:off x="2053318" y="5047185"/>
            <a:ext cx="1215221" cy="510426"/>
          </a:xfrm>
          <a:prstGeom prst="rect">
            <a:avLst/>
          </a:prstGeom>
        </p:spPr>
      </p:pic>
      <p:sp>
        <p:nvSpPr>
          <p:cNvPr id="94" name="Rectangle 93"/>
          <p:cNvSpPr/>
          <p:nvPr/>
        </p:nvSpPr>
        <p:spPr>
          <a:xfrm>
            <a:off x="823578" y="6188380"/>
            <a:ext cx="28979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d boxes are in the figure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504767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19552" y="1386613"/>
            <a:ext cx="4962144" cy="397459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5106" y="146367"/>
            <a:ext cx="4852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ul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edited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mmunoblot imag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or 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5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353909" y="3803453"/>
            <a:ext cx="28979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d boxes are in the figure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9" descr="C:\Users\FBM402\Desktop\Chemidoc Touch Images 2017-02-15_14.36.45\2017-02-15 13hr 54min 42sec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57" t="584" r="11557" b="2198"/>
          <a:stretch/>
        </p:blipFill>
        <p:spPr bwMode="auto">
          <a:xfrm flipH="1">
            <a:off x="138833" y="1778924"/>
            <a:ext cx="2847877" cy="193686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9" descr="C:\Users\FBM402\Desktop\Chemidoc Touch Images 2017-02-15_14.36.45\2017-02-15 13hr 54min 42sec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21" t="224" r="13607" b="-448"/>
          <a:stretch/>
        </p:blipFill>
        <p:spPr bwMode="auto">
          <a:xfrm flipH="1">
            <a:off x="3050771" y="1778924"/>
            <a:ext cx="2904720" cy="197011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Rectangle 9"/>
          <p:cNvSpPr/>
          <p:nvPr/>
        </p:nvSpPr>
        <p:spPr>
          <a:xfrm>
            <a:off x="353909" y="897328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ERK1/2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00968" y="1408960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rmal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6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50244" b="11708"/>
          <a:stretch/>
        </p:blipFill>
        <p:spPr bwMode="auto">
          <a:xfrm>
            <a:off x="1633359" y="2099758"/>
            <a:ext cx="1134426" cy="2516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Rectangle 12"/>
          <p:cNvSpPr/>
          <p:nvPr/>
        </p:nvSpPr>
        <p:spPr>
          <a:xfrm>
            <a:off x="1575393" y="2405800"/>
            <a:ext cx="1237913" cy="1996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3288546" y="2364981"/>
            <a:ext cx="1216343" cy="2314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5" name="Picture 6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87" t="2487"/>
          <a:stretch/>
        </p:blipFill>
        <p:spPr bwMode="auto">
          <a:xfrm>
            <a:off x="3386081" y="2030681"/>
            <a:ext cx="1086922" cy="2843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3104593" y="1386614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rmal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7859936" y="1393033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lfr544 KO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7399276" y="2488926"/>
            <a:ext cx="1284777" cy="2327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8723175" y="2405800"/>
            <a:ext cx="1177284" cy="2327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1" name="Picture 6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50244" b="11708"/>
          <a:stretch/>
        </p:blipFill>
        <p:spPr bwMode="auto">
          <a:xfrm>
            <a:off x="7372639" y="1690004"/>
            <a:ext cx="1258928" cy="2440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6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87" t="2487"/>
          <a:stretch/>
        </p:blipFill>
        <p:spPr bwMode="auto">
          <a:xfrm>
            <a:off x="8684054" y="1684063"/>
            <a:ext cx="1105845" cy="227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55873423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2"/>
          <a:srcRect l="1551" t="6061" r="3442" b="2859"/>
          <a:stretch/>
        </p:blipFill>
        <p:spPr>
          <a:xfrm>
            <a:off x="8329319" y="1737154"/>
            <a:ext cx="2693324" cy="140485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1551" t="6061" r="3442" b="2859"/>
          <a:stretch/>
        </p:blipFill>
        <p:spPr>
          <a:xfrm>
            <a:off x="5523899" y="1745194"/>
            <a:ext cx="2693324" cy="1404851"/>
          </a:xfrm>
          <a:prstGeom prst="rect">
            <a:avLst/>
          </a:prstGeom>
        </p:spPr>
      </p:pic>
      <p:pic>
        <p:nvPicPr>
          <p:cNvPr id="24" name="Picture 6" descr="C:\Users\FBM402\Desktop\2017-02-09 11hr 55min 37sec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2" t="974" r="535" b="2594"/>
          <a:stretch/>
        </p:blipFill>
        <p:spPr bwMode="auto">
          <a:xfrm>
            <a:off x="3042459" y="1808895"/>
            <a:ext cx="2419003" cy="121252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6" descr="C:\Users\FBM402\Desktop\2017-02-09 11hr 55min 37sec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-1022" r="-462" b="-2"/>
          <a:stretch/>
        </p:blipFill>
        <p:spPr bwMode="auto">
          <a:xfrm>
            <a:off x="417435" y="1835997"/>
            <a:ext cx="2431847" cy="103077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65106" y="146367"/>
            <a:ext cx="4852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ul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edited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mmunoblot imag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or 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5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487959" y="3280784"/>
            <a:ext cx="28979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d boxes are in the figure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00968" y="1408960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rmal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6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50244" b="11708"/>
          <a:stretch/>
        </p:blipFill>
        <p:spPr bwMode="auto">
          <a:xfrm>
            <a:off x="458185" y="1999424"/>
            <a:ext cx="1134426" cy="2516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Rectangle 12"/>
          <p:cNvSpPr/>
          <p:nvPr/>
        </p:nvSpPr>
        <p:spPr>
          <a:xfrm>
            <a:off x="417436" y="2666110"/>
            <a:ext cx="1215924" cy="1996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4178007" y="2785571"/>
            <a:ext cx="1216343" cy="2314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5" name="Picture 6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87" t="2487"/>
          <a:stretch/>
        </p:blipFill>
        <p:spPr bwMode="auto">
          <a:xfrm>
            <a:off x="4241694" y="2473946"/>
            <a:ext cx="1086922" cy="2843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3385919" y="1423973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rmal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355498" y="1386613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lfr544 KO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8964467" y="1352704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lfr544 KO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5673731" y="2184553"/>
            <a:ext cx="1217484" cy="2327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9640822" y="2206823"/>
            <a:ext cx="1167608" cy="2327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1" name="Picture 6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50244" b="11708"/>
          <a:stretch/>
        </p:blipFill>
        <p:spPr bwMode="auto">
          <a:xfrm>
            <a:off x="5654639" y="1829848"/>
            <a:ext cx="1217484" cy="2700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6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87" t="2487"/>
          <a:stretch/>
        </p:blipFill>
        <p:spPr bwMode="auto">
          <a:xfrm>
            <a:off x="9640822" y="1897235"/>
            <a:ext cx="1150905" cy="289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317549" y="641219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LC3I/II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188694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" descr="C:\Users\FBM402\Desktop\Chemidoc Touch Images 2017-02-14_14.34.57\2017-02-14 10hr 21min 01sec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984" t="-4249" r="21220" b="-55895"/>
          <a:stretch/>
        </p:blipFill>
        <p:spPr bwMode="auto">
          <a:xfrm>
            <a:off x="8073918" y="1837068"/>
            <a:ext cx="2668384" cy="167917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2" descr="C:\Users\FBM402\Desktop\Chemidoc Touch Images 2017-02-14_14.34.57\2017-02-14 10hr 21min 01sec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21" t="7814" r="23034" b="-74287"/>
          <a:stretch/>
        </p:blipFill>
        <p:spPr bwMode="auto">
          <a:xfrm>
            <a:off x="5201871" y="1828800"/>
            <a:ext cx="2818014" cy="156279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7" descr="C:\Users\FBM402\Desktop\Chemidoc Touch Images 2017-01-12_13.53.34\tu2017-01-12 12hr 03min 30sec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871" t="-55788" r="419" b="-133463"/>
          <a:stretch/>
        </p:blipFill>
        <p:spPr bwMode="auto">
          <a:xfrm flipH="1">
            <a:off x="3104593" y="1828800"/>
            <a:ext cx="1928554" cy="162929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3" descr="C:\Users\FBM402\Desktop\Chemidoc Touch Images 2016-11-04_16.17.19\tub2016-11-04 13hr 12min 39sec.tif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70" t="-368" r="-1441" b="-6165"/>
          <a:stretch/>
        </p:blipFill>
        <p:spPr bwMode="auto">
          <a:xfrm flipH="1">
            <a:off x="236198" y="1821167"/>
            <a:ext cx="2743200" cy="163760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65106" y="146367"/>
            <a:ext cx="4852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ul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edited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mmunoblot imag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or 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5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334174" y="3807104"/>
            <a:ext cx="28979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d boxes are in the figure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00968" y="1408960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rmal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6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50244" b="11708"/>
          <a:stretch/>
        </p:blipFill>
        <p:spPr bwMode="auto">
          <a:xfrm>
            <a:off x="877586" y="2103237"/>
            <a:ext cx="1134426" cy="2516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Rectangle 12"/>
          <p:cNvSpPr/>
          <p:nvPr/>
        </p:nvSpPr>
        <p:spPr>
          <a:xfrm>
            <a:off x="774099" y="2414775"/>
            <a:ext cx="1237913" cy="1996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3673615" y="2382958"/>
            <a:ext cx="1216343" cy="2314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5" name="Picture 6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87" t="2487"/>
          <a:stretch/>
        </p:blipFill>
        <p:spPr bwMode="auto">
          <a:xfrm>
            <a:off x="3738325" y="2086881"/>
            <a:ext cx="1086922" cy="2843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3104593" y="1386614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rmal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355498" y="1386613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lfr544 KO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8814315" y="1426250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lfr544 KO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5545087" y="2182019"/>
            <a:ext cx="1217484" cy="2327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9287934" y="2354866"/>
            <a:ext cx="1167608" cy="2327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1" name="Picture 6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50244" b="11708"/>
          <a:stretch/>
        </p:blipFill>
        <p:spPr bwMode="auto">
          <a:xfrm>
            <a:off x="5576441" y="1837068"/>
            <a:ext cx="1217484" cy="2700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6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87" t="2487"/>
          <a:stretch/>
        </p:blipFill>
        <p:spPr bwMode="auto">
          <a:xfrm>
            <a:off x="9287934" y="2026234"/>
            <a:ext cx="1150905" cy="289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463132" y="777663"/>
            <a:ext cx="10743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41564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-204475" y="4243997"/>
            <a:ext cx="10883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2751513" y="4746567"/>
            <a:ext cx="1845425" cy="4405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1" name="Picture 2" descr="C:\Users\FBM402\Desktop\pgc_1_2016-11-18 13hr 52min 24sec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0" t="-3985" r="-2006" b="3101"/>
          <a:stretch/>
        </p:blipFill>
        <p:spPr bwMode="auto">
          <a:xfrm>
            <a:off x="970523" y="1202954"/>
            <a:ext cx="3959091" cy="280897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2" descr="C:\Users\FBM402\Desktop\Chemidoc Touch Images 2016-11-15_16.34.23\a2016-11-15 10hr 53min 32sec.tif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773" t="20025" r="22739" b="40551"/>
          <a:stretch/>
        </p:blipFill>
        <p:spPr bwMode="auto">
          <a:xfrm>
            <a:off x="970523" y="4062787"/>
            <a:ext cx="5106081" cy="225711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0" name="Rectangle 39"/>
          <p:cNvSpPr/>
          <p:nvPr/>
        </p:nvSpPr>
        <p:spPr>
          <a:xfrm>
            <a:off x="2557249" y="5187852"/>
            <a:ext cx="1594421" cy="28981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/>
          <p:cNvSpPr txBox="1"/>
          <p:nvPr/>
        </p:nvSpPr>
        <p:spPr>
          <a:xfrm>
            <a:off x="65106" y="146367"/>
            <a:ext cx="49936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ul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edited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mmunoblot imag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or 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1D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1521241" y="2099444"/>
            <a:ext cx="1358415" cy="3422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367"/>
          <a:stretch/>
        </p:blipFill>
        <p:spPr>
          <a:xfrm>
            <a:off x="5088485" y="1246344"/>
            <a:ext cx="1986566" cy="2722190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248353" y="900523"/>
            <a:ext cx="8071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GC-1</a:t>
            </a:r>
            <a:r>
              <a:rPr lang="el-GR" altLang="ko-KR" sz="1200" dirty="0" smtClean="0">
                <a:latin typeface="Arial" pitchFamily="34" charset="0"/>
                <a:cs typeface="Arial" pitchFamily="34" charset="0"/>
              </a:rPr>
              <a:t>α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1055531" y="6319906"/>
            <a:ext cx="28979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d boxes are in the figure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181113" y="1762827"/>
            <a:ext cx="2970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zA   0  12.5 25 50  0 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.5 25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50308" y="4942841"/>
            <a:ext cx="55353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zA   0   12.5  25    50    0   12.5   25    50           0  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.5   25  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674455" y="1672297"/>
            <a:ext cx="22524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zA   0    12.5    25     50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17012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450" t="1928" r="1194" b="2229"/>
          <a:stretch/>
        </p:blipFill>
        <p:spPr>
          <a:xfrm>
            <a:off x="1053531" y="3729155"/>
            <a:ext cx="3416531" cy="2326641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65106" y="146367"/>
            <a:ext cx="4852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ul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edited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mmunoblot imag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or 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1F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-60757" y="3532320"/>
            <a:ext cx="10883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30419" y="775460"/>
            <a:ext cx="8071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GC-1</a:t>
            </a:r>
            <a:r>
              <a:rPr lang="el-GR" altLang="ko-KR" sz="1200" dirty="0" smtClean="0">
                <a:latin typeface="Arial" pitchFamily="34" charset="0"/>
                <a:cs typeface="Arial" pitchFamily="34" charset="0"/>
              </a:rPr>
              <a:t>α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1062991" y="5005636"/>
            <a:ext cx="1515923" cy="372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6" name="Group 15"/>
          <p:cNvGrpSpPr/>
          <p:nvPr/>
        </p:nvGrpSpPr>
        <p:grpSpPr>
          <a:xfrm>
            <a:off x="944225" y="1217356"/>
            <a:ext cx="5376840" cy="2017616"/>
            <a:chOff x="6878087" y="2144609"/>
            <a:chExt cx="5376840" cy="2017616"/>
          </a:xfrm>
        </p:grpSpPr>
        <p:pic>
          <p:nvPicPr>
            <p:cNvPr id="18" name="Picture 17" descr="Untitled.pn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566" b="-1405"/>
            <a:stretch/>
          </p:blipFill>
          <p:spPr>
            <a:xfrm>
              <a:off x="6878087" y="2144609"/>
              <a:ext cx="1634689" cy="2017616"/>
            </a:xfrm>
            <a:prstGeom prst="rect">
              <a:avLst/>
            </a:prstGeom>
          </p:spPr>
        </p:pic>
        <p:pic>
          <p:nvPicPr>
            <p:cNvPr id="22" name="Picture 3" descr="C:\Users\FBM402\Desktop\Chemidoc Touch Images 2017-01-18_16.30.49-pCREB,CREB\2017-01-18 16hr 14min 06sec-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0" t="235" r="-2" b="-4101"/>
            <a:stretch/>
          </p:blipFill>
          <p:spPr bwMode="auto">
            <a:xfrm>
              <a:off x="9002560" y="2205744"/>
              <a:ext cx="3252367" cy="1796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45" name="Rectangle 44"/>
          <p:cNvSpPr/>
          <p:nvPr/>
        </p:nvSpPr>
        <p:spPr>
          <a:xfrm>
            <a:off x="4720315" y="1616244"/>
            <a:ext cx="1600750" cy="3095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6" name="Picture 4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86981" y="1047529"/>
            <a:ext cx="1968146" cy="607314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5"/>
          <a:srcRect l="27009" b="644"/>
          <a:stretch/>
        </p:blipFill>
        <p:spPr>
          <a:xfrm>
            <a:off x="4754863" y="1033525"/>
            <a:ext cx="1574515" cy="661339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6099" y="1054834"/>
            <a:ext cx="2077189" cy="640961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0768" y="4490401"/>
            <a:ext cx="1968146" cy="607314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5"/>
          <a:srcRect l="27009" b="644"/>
          <a:stretch/>
        </p:blipFill>
        <p:spPr>
          <a:xfrm>
            <a:off x="2986240" y="4490401"/>
            <a:ext cx="1574515" cy="661339"/>
          </a:xfrm>
          <a:prstGeom prst="rect">
            <a:avLst/>
          </a:prstGeom>
        </p:spPr>
      </p:pic>
      <p:sp>
        <p:nvSpPr>
          <p:cNvPr id="51" name="Rectangle 50"/>
          <p:cNvSpPr/>
          <p:nvPr/>
        </p:nvSpPr>
        <p:spPr>
          <a:xfrm>
            <a:off x="937597" y="6183867"/>
            <a:ext cx="4582054" cy="6617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d boxes are in the figure.</a:t>
            </a:r>
          </a:p>
          <a:p>
            <a:pPr>
              <a:spcAft>
                <a:spcPts val="600"/>
              </a:spcAft>
            </a:pP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ame </a:t>
            </a:r>
            <a:r>
              <a:rPr lang="el-G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-actin control was used for Figure 4C. 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5"/>
          <a:srcRect l="27009" b="644"/>
          <a:stretch/>
        </p:blipFill>
        <p:spPr>
          <a:xfrm>
            <a:off x="4645004" y="4436376"/>
            <a:ext cx="1439913" cy="598707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55127" y="4106737"/>
            <a:ext cx="1377815" cy="21886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04002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65106" y="146367"/>
            <a:ext cx="4852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ul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edited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mmunoblot imag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or Figure 4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Group 25"/>
          <p:cNvGrpSpPr/>
          <p:nvPr/>
        </p:nvGrpSpPr>
        <p:grpSpPr>
          <a:xfrm>
            <a:off x="439179" y="541156"/>
            <a:ext cx="8932704" cy="4993107"/>
            <a:chOff x="6432953" y="3879592"/>
            <a:chExt cx="8932704" cy="4993107"/>
          </a:xfrm>
        </p:grpSpPr>
        <p:pic>
          <p:nvPicPr>
            <p:cNvPr id="47" name="Picture 2" descr="C:\Users\FBM402\Desktop\Olfr544_muscle_Mitochondrial biogenesis\IB\Chemidoc Touch Images 2016-12-01_19.28.09_siRNA\actin_2016-12-01 11hr 29min 50sec.tif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93" t="8231" r="13880" b="40030"/>
            <a:stretch/>
          </p:blipFill>
          <p:spPr bwMode="auto">
            <a:xfrm>
              <a:off x="11895996" y="4775837"/>
              <a:ext cx="3469661" cy="14840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8" name="TextBox 47"/>
            <p:cNvSpPr txBox="1"/>
            <p:nvPr/>
          </p:nvSpPr>
          <p:spPr>
            <a:xfrm>
              <a:off x="11510868" y="4189913"/>
              <a:ext cx="728431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l-GR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9" name="Picture 3" descr="C:\Users\FBM402\Desktop\Olfr544_muscle_Mitochondrial biogenesis\IB\Chemidoc Touch Images 2016-12-01_19.28.09_siRNA\pERK_2016-12-01 19hr 24min 20sec+2016-12-01 19hr 27min 11sec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777" t="15561" r="20696" b="20845"/>
            <a:stretch/>
          </p:blipFill>
          <p:spPr bwMode="auto">
            <a:xfrm>
              <a:off x="9680713" y="6848065"/>
              <a:ext cx="1225131" cy="20246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0" name="TextBox 49"/>
            <p:cNvSpPr txBox="1"/>
            <p:nvPr/>
          </p:nvSpPr>
          <p:spPr>
            <a:xfrm>
              <a:off x="6432953" y="3997240"/>
              <a:ext cx="91185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RK1/2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6511561" y="6511086"/>
              <a:ext cx="91185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RK1/2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2" name="Picture 2" descr="C:\Users\FBM402\Desktop\pERK_PGC1_Chemidoc Touch Images 2016-12-07_18.11.23\pERK2016-12-07 11hr 21min 59sec.ti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795" t="12664" r="14613" b="39034"/>
            <a:stretch/>
          </p:blipFill>
          <p:spPr bwMode="auto">
            <a:xfrm>
              <a:off x="7694004" y="3879592"/>
              <a:ext cx="3211840" cy="23544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3" name="Picture 4" descr="C:\Users\FBM402\Desktop\2017-02-09 11hr 03min 46sec.tif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188" r="16136" b="88"/>
            <a:stretch/>
          </p:blipFill>
          <p:spPr bwMode="auto">
            <a:xfrm flipH="1">
              <a:off x="7327973" y="6894684"/>
              <a:ext cx="2314843" cy="9930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pic>
        <p:nvPicPr>
          <p:cNvPr id="54" name="Picture 5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34199" y="1076452"/>
            <a:ext cx="1474887" cy="455108"/>
          </a:xfrm>
          <a:prstGeom prst="rect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 rotWithShape="1">
          <a:blip r:embed="rId8"/>
          <a:srcRect l="27009" b="644"/>
          <a:stretch/>
        </p:blipFill>
        <p:spPr>
          <a:xfrm>
            <a:off x="2743751" y="1084444"/>
            <a:ext cx="1096729" cy="460655"/>
          </a:xfrm>
          <a:prstGeom prst="rect">
            <a:avLst/>
          </a:prstGeom>
        </p:spPr>
      </p:pic>
      <p:pic>
        <p:nvPicPr>
          <p:cNvPr id="56" name="Picture 55"/>
          <p:cNvPicPr>
            <a:picLocks noChangeAspect="1"/>
          </p:cNvPicPr>
          <p:nvPr/>
        </p:nvPicPr>
        <p:blipFill rotWithShape="1">
          <a:blip r:embed="rId8"/>
          <a:srcRect l="27009" b="644"/>
          <a:stretch/>
        </p:blipFill>
        <p:spPr>
          <a:xfrm>
            <a:off x="3754020" y="1087647"/>
            <a:ext cx="1096729" cy="460655"/>
          </a:xfrm>
          <a:prstGeom prst="rect">
            <a:avLst/>
          </a:prstGeom>
        </p:spPr>
      </p:pic>
      <p:sp>
        <p:nvSpPr>
          <p:cNvPr id="57" name="Rectangle 56"/>
          <p:cNvSpPr/>
          <p:nvPr/>
        </p:nvSpPr>
        <p:spPr>
          <a:xfrm>
            <a:off x="3754020" y="1437400"/>
            <a:ext cx="1096729" cy="2334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8" name="Picture 5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43754" y="3731863"/>
            <a:ext cx="1474887" cy="455108"/>
          </a:xfrm>
          <a:prstGeom prst="rect">
            <a:avLst/>
          </a:prstGeom>
        </p:spPr>
      </p:pic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8"/>
          <a:srcRect l="27009" b="644"/>
          <a:stretch/>
        </p:blipFill>
        <p:spPr>
          <a:xfrm>
            <a:off x="2546292" y="3729648"/>
            <a:ext cx="1096729" cy="460655"/>
          </a:xfrm>
          <a:prstGeom prst="rect">
            <a:avLst/>
          </a:prstGeom>
        </p:spPr>
      </p:pic>
      <p:pic>
        <p:nvPicPr>
          <p:cNvPr id="60" name="Picture 59"/>
          <p:cNvPicPr>
            <a:picLocks noChangeAspect="1"/>
          </p:cNvPicPr>
          <p:nvPr/>
        </p:nvPicPr>
        <p:blipFill rotWithShape="1">
          <a:blip r:embed="rId8"/>
          <a:srcRect l="27009" b="644"/>
          <a:stretch/>
        </p:blipFill>
        <p:spPr>
          <a:xfrm>
            <a:off x="3784391" y="3726316"/>
            <a:ext cx="1096729" cy="460655"/>
          </a:xfrm>
          <a:prstGeom prst="rect">
            <a:avLst/>
          </a:prstGeom>
        </p:spPr>
      </p:pic>
      <p:sp>
        <p:nvSpPr>
          <p:cNvPr id="61" name="Rectangle 60"/>
          <p:cNvSpPr/>
          <p:nvPr/>
        </p:nvSpPr>
        <p:spPr>
          <a:xfrm>
            <a:off x="2518147" y="4244511"/>
            <a:ext cx="1096729" cy="2334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2" name="Picture 6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586042" y="1740596"/>
            <a:ext cx="1502538" cy="455108"/>
          </a:xfrm>
          <a:prstGeom prst="rect">
            <a:avLst/>
          </a:prstGeom>
        </p:spPr>
      </p:pic>
      <p:pic>
        <p:nvPicPr>
          <p:cNvPr id="63" name="Picture 62"/>
          <p:cNvPicPr>
            <a:picLocks noChangeAspect="1"/>
          </p:cNvPicPr>
          <p:nvPr/>
        </p:nvPicPr>
        <p:blipFill rotWithShape="1">
          <a:blip r:embed="rId8"/>
          <a:srcRect l="27009" b="644"/>
          <a:stretch/>
        </p:blipFill>
        <p:spPr>
          <a:xfrm>
            <a:off x="7088580" y="1738381"/>
            <a:ext cx="1096729" cy="460655"/>
          </a:xfrm>
          <a:prstGeom prst="rect">
            <a:avLst/>
          </a:prstGeom>
        </p:spPr>
      </p:pic>
      <p:pic>
        <p:nvPicPr>
          <p:cNvPr id="64" name="Picture 63"/>
          <p:cNvPicPr>
            <a:picLocks noChangeAspect="1"/>
          </p:cNvPicPr>
          <p:nvPr/>
        </p:nvPicPr>
        <p:blipFill rotWithShape="1">
          <a:blip r:embed="rId8"/>
          <a:srcRect l="27009" b="644"/>
          <a:stretch/>
        </p:blipFill>
        <p:spPr>
          <a:xfrm>
            <a:off x="8177051" y="1726736"/>
            <a:ext cx="1096729" cy="460655"/>
          </a:xfrm>
          <a:prstGeom prst="rect">
            <a:avLst/>
          </a:prstGeom>
        </p:spPr>
      </p:pic>
      <p:sp>
        <p:nvSpPr>
          <p:cNvPr id="66" name="Rectangle 65"/>
          <p:cNvSpPr/>
          <p:nvPr/>
        </p:nvSpPr>
        <p:spPr>
          <a:xfrm>
            <a:off x="8191307" y="2260678"/>
            <a:ext cx="1082474" cy="2334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9487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0270" y="4278638"/>
            <a:ext cx="1383912" cy="1963082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65106" y="146367"/>
            <a:ext cx="4865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ul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edited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mmunoblot imag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or 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4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10768" y="522712"/>
            <a:ext cx="7284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C3 I</a:t>
            </a:r>
          </a:p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C3 II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3"/>
          <a:srcRect l="450" t="1928" r="1194" b="2229"/>
          <a:stretch/>
        </p:blipFill>
        <p:spPr>
          <a:xfrm>
            <a:off x="1053531" y="3729155"/>
            <a:ext cx="3416531" cy="2326641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>
            <a:off x="-60757" y="3532320"/>
            <a:ext cx="10883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4645966" y="4957085"/>
            <a:ext cx="1397388" cy="372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9" name="Picture 4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0768" y="4490401"/>
            <a:ext cx="1968146" cy="607314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4"/>
          <a:srcRect l="27009" b="644"/>
          <a:stretch/>
        </p:blipFill>
        <p:spPr>
          <a:xfrm>
            <a:off x="3021677" y="4523651"/>
            <a:ext cx="1574515" cy="661339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4"/>
          <a:srcRect l="27009" b="644"/>
          <a:stretch/>
        </p:blipFill>
        <p:spPr>
          <a:xfrm>
            <a:off x="4717754" y="4523651"/>
            <a:ext cx="1372346" cy="576423"/>
          </a:xfrm>
          <a:prstGeom prst="rect">
            <a:avLst/>
          </a:prstGeom>
        </p:spPr>
      </p:pic>
      <p:sp>
        <p:nvSpPr>
          <p:cNvPr id="52" name="Rectangle 51"/>
          <p:cNvSpPr/>
          <p:nvPr/>
        </p:nvSpPr>
        <p:spPr>
          <a:xfrm>
            <a:off x="823578" y="6188380"/>
            <a:ext cx="28979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d boxes are in the figure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6065" y="940482"/>
            <a:ext cx="3380028" cy="2601537"/>
          </a:xfrm>
          <a:prstGeom prst="rect">
            <a:avLst/>
          </a:prstGeom>
        </p:spPr>
      </p:pic>
      <p:cxnSp>
        <p:nvCxnSpPr>
          <p:cNvPr id="8" name="Straight Arrow Connector 7"/>
          <p:cNvCxnSpPr/>
          <p:nvPr/>
        </p:nvCxnSpPr>
        <p:spPr>
          <a:xfrm>
            <a:off x="974983" y="2913577"/>
            <a:ext cx="20403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9" name="Picture 2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6509" y="1827373"/>
            <a:ext cx="1832390" cy="585837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4"/>
          <a:srcRect l="27009" b="644"/>
          <a:stretch/>
        </p:blipFill>
        <p:spPr>
          <a:xfrm>
            <a:off x="2526038" y="1843990"/>
            <a:ext cx="1360161" cy="571305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6"/>
          <a:srcRect l="1954" t="1249" r="2601" b="2767"/>
          <a:stretch/>
        </p:blipFill>
        <p:spPr>
          <a:xfrm>
            <a:off x="4717754" y="1330133"/>
            <a:ext cx="1372346" cy="2340686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4"/>
          <a:srcRect l="27009" b="644"/>
          <a:stretch/>
        </p:blipFill>
        <p:spPr>
          <a:xfrm>
            <a:off x="4694021" y="1832499"/>
            <a:ext cx="1360161" cy="5713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92436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" descr="C:\Users\FBM402\Desktop\Chemidoc Touch Images 2017-01-18_16.30.49-pCREB,CREB\2017-01-18 16hr 14min 06sec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9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514" t="17138" r="12453" b="7272"/>
          <a:stretch/>
        </p:blipFill>
        <p:spPr bwMode="auto">
          <a:xfrm>
            <a:off x="183148" y="1684786"/>
            <a:ext cx="2796145" cy="166117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8" descr="C:\Users\FBM402\Desktop\그림1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67" t="12841" r="-152" b="783"/>
          <a:stretch/>
        </p:blipFill>
        <p:spPr bwMode="auto">
          <a:xfrm>
            <a:off x="3023178" y="1718259"/>
            <a:ext cx="2853229" cy="165254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6" descr="C:\Users\FBM402\Desktop\Chemidoc Touch Images 2017-02-14_14.34.57\2017-02-14 11hr 10min 34sec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74" t="14621" r="29234" b="-1866"/>
          <a:stretch/>
        </p:blipFill>
        <p:spPr bwMode="auto">
          <a:xfrm>
            <a:off x="5927708" y="1732879"/>
            <a:ext cx="3039534" cy="21336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7" descr="C:\Users\FBM402\Desktop\Chemidoc Touch Images 2017-02-14_14.34.57\2017-02-14 11hr 12min 47sec.ti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180" t="18711" r="28684" b="-359"/>
          <a:stretch/>
        </p:blipFill>
        <p:spPr bwMode="auto">
          <a:xfrm>
            <a:off x="9018543" y="1741246"/>
            <a:ext cx="3009207" cy="18288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0" name="Rectangle 39"/>
          <p:cNvSpPr/>
          <p:nvPr/>
        </p:nvSpPr>
        <p:spPr>
          <a:xfrm>
            <a:off x="307032" y="705428"/>
            <a:ext cx="9541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dirty="0" err="1">
                <a:latin typeface="Arial" panose="020B0604020202020204" pitchFamily="34" charset="0"/>
                <a:cs typeface="Arial" panose="020B0604020202020204" pitchFamily="34" charset="0"/>
              </a:rPr>
              <a:t>pCREB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5106" y="146367"/>
            <a:ext cx="4852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ul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edited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mmunoblot imag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or 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5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Picture 6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50244" b="11708"/>
          <a:stretch/>
        </p:blipFill>
        <p:spPr bwMode="auto">
          <a:xfrm>
            <a:off x="921301" y="2378293"/>
            <a:ext cx="1194167" cy="2648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4" name="Rectangle 43"/>
          <p:cNvSpPr/>
          <p:nvPr/>
        </p:nvSpPr>
        <p:spPr>
          <a:xfrm>
            <a:off x="784086" y="2673278"/>
            <a:ext cx="1331382" cy="2528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/>
          <p:cNvSpPr/>
          <p:nvPr/>
        </p:nvSpPr>
        <p:spPr>
          <a:xfrm>
            <a:off x="4083197" y="2709882"/>
            <a:ext cx="1721632" cy="21619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6" name="Picture 6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87" t="2487"/>
          <a:stretch/>
        </p:blipFill>
        <p:spPr bwMode="auto">
          <a:xfrm>
            <a:off x="4173688" y="2311118"/>
            <a:ext cx="1489500" cy="374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7" name="Rectangle 46"/>
          <p:cNvSpPr/>
          <p:nvPr/>
        </p:nvSpPr>
        <p:spPr>
          <a:xfrm>
            <a:off x="6278871" y="2194740"/>
            <a:ext cx="1217484" cy="2327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/>
          <p:cNvSpPr/>
          <p:nvPr/>
        </p:nvSpPr>
        <p:spPr>
          <a:xfrm>
            <a:off x="10445272" y="2007397"/>
            <a:ext cx="1167608" cy="2327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9" name="Picture 6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50244" b="11708"/>
          <a:stretch/>
        </p:blipFill>
        <p:spPr bwMode="auto">
          <a:xfrm>
            <a:off x="6278871" y="1828784"/>
            <a:ext cx="1217484" cy="2700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0" name="Picture 6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87" t="2487"/>
          <a:stretch/>
        </p:blipFill>
        <p:spPr bwMode="auto">
          <a:xfrm>
            <a:off x="10418422" y="1709725"/>
            <a:ext cx="1150905" cy="289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3" name="TextBox 52"/>
          <p:cNvSpPr txBox="1"/>
          <p:nvPr/>
        </p:nvSpPr>
        <p:spPr>
          <a:xfrm>
            <a:off x="657689" y="1264489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rmal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446759" y="1267064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rmal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6600053" y="1275533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lfr544 KO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9753347" y="1291144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lfr544 KO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453638" y="4399450"/>
            <a:ext cx="28979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d boxes are in the figure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79555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5" descr="C:\Users\FBM402\Desktop\Chemidoc Touch Images 2017-01-12_13.53.34\2017-01-12 12hr 40min 43sec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085" t="-512" r="-3519" b="1068"/>
          <a:stretch/>
        </p:blipFill>
        <p:spPr bwMode="auto">
          <a:xfrm>
            <a:off x="238695" y="1252473"/>
            <a:ext cx="2296696" cy="392097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6" descr="C:\Users\FBM402\Desktop\Chemidoc Touch Images 2017-01-18_16.30.49-pCREB,CREB\2017-01-18 16hr 22min 32sec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841" t="1139" r="15386" b="7134"/>
          <a:stretch/>
        </p:blipFill>
        <p:spPr bwMode="auto">
          <a:xfrm>
            <a:off x="2675845" y="919964"/>
            <a:ext cx="3205777" cy="304441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5" descr="C:\Users\FBM402\Desktop\Chemidoc Touch Images 2017-02-15_14.36.45\2017-02-15 11hr 38min 56sec.ti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458" t="3664" r="21858" b="1297"/>
          <a:stretch/>
        </p:blipFill>
        <p:spPr bwMode="auto">
          <a:xfrm>
            <a:off x="9097840" y="991304"/>
            <a:ext cx="2954867" cy="215152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6" descr="C:\Users\FBM402\Desktop\Chemidoc Touch Images 2017-02-15_14.36.45\2017-02-15 12hr 07min 14sec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613" t="-2519" r="18105" b="1143"/>
          <a:stretch/>
        </p:blipFill>
        <p:spPr bwMode="auto">
          <a:xfrm>
            <a:off x="5955336" y="969933"/>
            <a:ext cx="3025833" cy="294447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11226840" y="117315"/>
            <a:ext cx="825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CREB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94955" y="796314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rmal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50244" b="11708"/>
          <a:stretch/>
        </p:blipFill>
        <p:spPr bwMode="auto">
          <a:xfrm>
            <a:off x="1117941" y="1834312"/>
            <a:ext cx="997527" cy="221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Rectangle 9"/>
          <p:cNvSpPr/>
          <p:nvPr/>
        </p:nvSpPr>
        <p:spPr>
          <a:xfrm>
            <a:off x="1030779" y="2103120"/>
            <a:ext cx="1072342" cy="2327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858821" y="1878677"/>
            <a:ext cx="1078938" cy="2327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87" t="2487"/>
          <a:stretch/>
        </p:blipFill>
        <p:spPr bwMode="auto">
          <a:xfrm>
            <a:off x="3786854" y="1539097"/>
            <a:ext cx="1150905" cy="289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3427865" y="577170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rmal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581159" y="585639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lfr544 KO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9734453" y="601250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lfr544 KO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6205781" y="1834312"/>
            <a:ext cx="1217484" cy="2327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10353832" y="1450928"/>
            <a:ext cx="1167608" cy="2327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8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50244" b="11708"/>
          <a:stretch/>
        </p:blipFill>
        <p:spPr bwMode="auto">
          <a:xfrm>
            <a:off x="6205781" y="1486429"/>
            <a:ext cx="1217484" cy="2700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87" t="2487"/>
          <a:stretch/>
        </p:blipFill>
        <p:spPr bwMode="auto">
          <a:xfrm>
            <a:off x="10353832" y="1107885"/>
            <a:ext cx="1150905" cy="289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65106" y="146367"/>
            <a:ext cx="4852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ul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edited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mmunoblot imag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or 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5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317549" y="5910224"/>
            <a:ext cx="28979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d boxes are in the figure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06201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5106" y="146367"/>
            <a:ext cx="4852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ul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edited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mmunoblot imag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or 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5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C:\Users\FBM402\Desktop\Chemidoc Touch Images 2016-11-04_16.17.19\pgc1_2016-11-04 12hr 52min 34sec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923" t="-2342" r="-153" b="-3104"/>
          <a:stretch/>
        </p:blipFill>
        <p:spPr bwMode="auto">
          <a:xfrm flipH="1">
            <a:off x="65106" y="1791394"/>
            <a:ext cx="2387149" cy="133236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6" descr="C:\Users\FBM402\Desktop\Chemidoc Touch Images 2017-01-13_11.22.16\2017-01-13 10hr 31min 41sec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51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54" t="18539" r="1763" b="5207"/>
          <a:stretch/>
        </p:blipFill>
        <p:spPr bwMode="auto">
          <a:xfrm flipH="1">
            <a:off x="2610909" y="1675014"/>
            <a:ext cx="2624437" cy="233166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2" descr="C:\Users\FBM402\Desktop\Chemidoc Touch Images 2017-02-14_14.34.57\2017-02-14 11hr 30min 19sec.ti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725" t="12327" r="19326" b="15976"/>
          <a:stretch/>
        </p:blipFill>
        <p:spPr bwMode="auto">
          <a:xfrm flipH="1">
            <a:off x="8728363" y="1774767"/>
            <a:ext cx="3200399" cy="158773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2" descr="C:\Users\FBM402\Desktop\Chemidoc Touch Images 2017-02-14_14.34.57\2017-02-14 11hr 30min 19sec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533" t="6578" r="16827" b="22589"/>
          <a:stretch/>
        </p:blipFill>
        <p:spPr bwMode="auto">
          <a:xfrm flipH="1">
            <a:off x="5235346" y="1791394"/>
            <a:ext cx="3325091" cy="157110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/>
          <p:cNvSpPr/>
          <p:nvPr/>
        </p:nvSpPr>
        <p:spPr>
          <a:xfrm>
            <a:off x="284729" y="888161"/>
            <a:ext cx="10230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PGC-1</a:t>
            </a:r>
            <a:r>
              <a:rPr lang="el-GR" altLang="ko-KR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53638" y="1494583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rmal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50244" b="11708"/>
          <a:stretch/>
        </p:blipFill>
        <p:spPr bwMode="auto">
          <a:xfrm>
            <a:off x="885567" y="1874066"/>
            <a:ext cx="1400432" cy="3106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Rectangle 9"/>
          <p:cNvSpPr/>
          <p:nvPr/>
        </p:nvSpPr>
        <p:spPr>
          <a:xfrm>
            <a:off x="796248" y="2265575"/>
            <a:ext cx="1489751" cy="1891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437466" y="2223316"/>
            <a:ext cx="1433258" cy="2314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87" t="2487"/>
          <a:stretch/>
        </p:blipFill>
        <p:spPr bwMode="auto">
          <a:xfrm>
            <a:off x="3414924" y="1803861"/>
            <a:ext cx="1455800" cy="3808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3286548" y="1275439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rmal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439842" y="1283908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lfr544 KO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9593136" y="1299519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lfr544 KO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5518640" y="2360162"/>
            <a:ext cx="1217484" cy="2327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10067064" y="2176259"/>
            <a:ext cx="1167608" cy="2327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8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50244" b="11708"/>
          <a:stretch/>
        </p:blipFill>
        <p:spPr bwMode="auto">
          <a:xfrm>
            <a:off x="5554705" y="2066824"/>
            <a:ext cx="1217484" cy="2700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87" t="2487"/>
          <a:stretch/>
        </p:blipFill>
        <p:spPr bwMode="auto">
          <a:xfrm>
            <a:off x="10033969" y="1891032"/>
            <a:ext cx="1150905" cy="289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Rectangle 19"/>
          <p:cNvSpPr/>
          <p:nvPr/>
        </p:nvSpPr>
        <p:spPr>
          <a:xfrm>
            <a:off x="453638" y="4399450"/>
            <a:ext cx="28979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d boxes are in the figure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45802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5106" y="146367"/>
            <a:ext cx="4852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ul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nedited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mmunoblot imag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or 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5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20" descr="C:\Users\FBM402\Desktop\Chemidoc Touch Images 2017-01-13_11.22.16\2017-01-13 10hr 36min 08sec--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471" t="385" r="-430" b="-611"/>
          <a:stretch/>
        </p:blipFill>
        <p:spPr bwMode="auto">
          <a:xfrm flipH="1">
            <a:off x="399011" y="2090649"/>
            <a:ext cx="1978429" cy="139653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3" descr="C:\Users\FBM402\Desktop\Olfr544_muscle_Mitochondrial biogenesis - 복사본\IB\Chemidoc Touch Images 2017-02-16_17.08.51\2017-02-16 10hr 30min 36sec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013" t="10307" r="21283" b="47971"/>
          <a:stretch/>
        </p:blipFill>
        <p:spPr bwMode="auto">
          <a:xfrm>
            <a:off x="4989714" y="2115587"/>
            <a:ext cx="2876203" cy="114300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3" descr="C:\Users\FBM402\Desktop\Olfr544_muscle_Mitochondrial biogenesis - 복사본\IB\Chemidoc Touch Images 2017-02-16_17.08.51\2017-02-16 10hr 30min 36sec.ti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706" t="56711" r="11007" b="4061"/>
          <a:stretch/>
        </p:blipFill>
        <p:spPr bwMode="auto">
          <a:xfrm>
            <a:off x="7980216" y="2096884"/>
            <a:ext cx="3865419" cy="118040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3" descr="C:\Users\FBM402\Desktop\Olfr544_muscle_Mitochondrial biogenesis\IB\Chemidoc Touch Images 2016-11-09_17.08.21PGC1_pERK_muscle\2016-11-09 11hr 20min 11sec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92" t="-1826" r="1797" b="337"/>
          <a:stretch/>
        </p:blipFill>
        <p:spPr bwMode="auto">
          <a:xfrm flipV="1">
            <a:off x="2456411" y="2090649"/>
            <a:ext cx="2419004" cy="108896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ectangle 8"/>
          <p:cNvSpPr/>
          <p:nvPr/>
        </p:nvSpPr>
        <p:spPr>
          <a:xfrm>
            <a:off x="522470" y="834033"/>
            <a:ext cx="11079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pERK1/2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59404" y="1598643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rmal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50244" b="11708"/>
          <a:stretch/>
        </p:blipFill>
        <p:spPr bwMode="auto">
          <a:xfrm>
            <a:off x="1108079" y="1891032"/>
            <a:ext cx="1134426" cy="2516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Rectangle 11"/>
          <p:cNvSpPr/>
          <p:nvPr/>
        </p:nvSpPr>
        <p:spPr>
          <a:xfrm>
            <a:off x="1011510" y="2184698"/>
            <a:ext cx="1237913" cy="1996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3580101" y="2635132"/>
            <a:ext cx="1216343" cy="2314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4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87" t="2487"/>
          <a:stretch/>
        </p:blipFill>
        <p:spPr bwMode="auto">
          <a:xfrm>
            <a:off x="3644811" y="2170411"/>
            <a:ext cx="1086922" cy="2843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3063029" y="1576297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rmal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776130" y="1576296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lfr544 KO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9538045" y="1516029"/>
            <a:ext cx="1584176" cy="2923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lfr544 KO mice</a:t>
            </a:r>
            <a:endParaRPr lang="ko-KR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5253045" y="2518754"/>
            <a:ext cx="1217484" cy="2327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9850934" y="2554664"/>
            <a:ext cx="1167608" cy="2327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0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50244" b="11708"/>
          <a:stretch/>
        </p:blipFill>
        <p:spPr bwMode="auto">
          <a:xfrm>
            <a:off x="5253045" y="2170411"/>
            <a:ext cx="1217484" cy="2700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87" t="2487"/>
          <a:stretch/>
        </p:blipFill>
        <p:spPr bwMode="auto">
          <a:xfrm>
            <a:off x="9830174" y="2115587"/>
            <a:ext cx="1150905" cy="289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" name="Rectangle 21"/>
          <p:cNvSpPr/>
          <p:nvPr/>
        </p:nvSpPr>
        <p:spPr>
          <a:xfrm>
            <a:off x="226312" y="4205193"/>
            <a:ext cx="28979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d boxes are in the figure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8208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4</TotalTime>
  <Words>298</Words>
  <Application>Microsoft Office PowerPoint</Application>
  <PresentationFormat>Widescreen</PresentationFormat>
  <Paragraphs>77</Paragraphs>
  <Slides>1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8" baseType="lpstr">
      <vt:lpstr>맑은 고딕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 CHUNYAN</dc:creator>
  <cp:lastModifiedBy>WU CHUNYAN</cp:lastModifiedBy>
  <cp:revision>35</cp:revision>
  <dcterms:created xsi:type="dcterms:W3CDTF">2019-11-29T00:41:24Z</dcterms:created>
  <dcterms:modified xsi:type="dcterms:W3CDTF">2019-12-06T22:15:05Z</dcterms:modified>
</cp:coreProperties>
</file>